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556E4-CF6D-46D5-9941-6F918F53BA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6123F-3511-4A40-B9F0-258F51AD5D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4B947-F3D8-443D-B352-11EF3E576A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67EA9-3BDB-40CA-B2B4-B20025FCE4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B2C16-7B5A-4B03-AABB-3CEAEF07B0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24FDD-E1DF-42D3-A184-51D08BAF90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150C7-703E-45E0-94AE-CAC0C86B4D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5D387-D3E3-42BA-801E-48309DC4C4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2B513-5E6E-4FFA-A713-D6F374AEE8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5FB50-409E-4409-9EA6-41BFBF5C9D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4E2F0-7A52-492C-9C43-5DBBB238E8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39F2F-527D-4262-876C-A3E908513A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9A92D09-D814-4F72-895C-A60E0125BE71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1E7416D-2F6C-4F56-BF31-1057ED7817E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0960" y="998640"/>
          <a:ext cx="6647040" cy="4120920"/>
        </p:xfrm>
        <a:graphic>
          <a:graphicData uri="http://schemas.openxmlformats.org/drawingml/2006/table">
            <a:tbl>
              <a:tblPr/>
              <a:tblGrid>
                <a:gridCol w="779760"/>
                <a:gridCol w="1930320"/>
                <a:gridCol w="1422360"/>
                <a:gridCol w="1185840"/>
                <a:gridCol w="1328760"/>
              </a:tblGrid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amil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i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SG1 </a:t>
                      </a: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tations,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otein chang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l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lant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ther featur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508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517+5G&gt;C,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Tyr126Hisfs*2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oband - 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latives - Unaffec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c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c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544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76C&gt;T,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Arg26*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oband a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alf-sister - Foc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lative - 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c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c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nee and elbow hyperkerat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972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76C&gt;T,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Arg26*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ffu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orsal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interphalangeal hyperkerat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292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1560-1561del, p.Ser521Tyrfs*2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ffu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</a:rPr>
                        <a:t>Plantar pain if keratoderma thic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256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8G&gt;A,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Trp3*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c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292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1771_1784del14, p.Asp591Phefs*9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ffu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</a:rPr>
                        <a:t>Plantar pain if keratoderma thic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5080"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.746dupT,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.Met249Ilefs*6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ri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0" rIns="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ffu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nuckle and toe pad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3"/>
          <p:cNvSpPr/>
          <p:nvPr/>
        </p:nvSpPr>
        <p:spPr>
          <a:xfrm>
            <a:off x="210960" y="5308560"/>
            <a:ext cx="6647040" cy="82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able 1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-1219320" y="939960"/>
            <a:ext cx="18432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15T18:58:38Z</dcterms:created>
  <dc:creator>Will and Malou</dc:creator>
  <dc:description/>
  <dc:language>en-US</dc:language>
  <cp:lastModifiedBy>William Tremlett</cp:lastModifiedBy>
  <dcterms:modified xsi:type="dcterms:W3CDTF">2017-02-20T19:30:01Z</dcterms:modified>
  <cp:revision>25</cp:revision>
  <dc:subject/>
  <dc:title>Slide 1</dc:title>
</cp:coreProperties>
</file>